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7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824"/>
    <p:restoredTop sz="83599"/>
  </p:normalViewPr>
  <p:slideViewPr>
    <p:cSldViewPr snapToGrid="0">
      <p:cViewPr varScale="1">
        <p:scale>
          <a:sx n="68" d="100"/>
          <a:sy n="68" d="100"/>
        </p:scale>
        <p:origin x="3536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SG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1C2482-C3F4-924F-8E2C-ECE46DBCF5FD}" type="datetimeFigureOut">
              <a:rPr kumimoji="1" lang="zh-SG" altLang="en-US" smtClean="0"/>
              <a:t>20/02/26</a:t>
            </a:fld>
            <a:endParaRPr kumimoji="1" lang="zh-SG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SG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  <a:endParaRPr kumimoji="1" lang="zh-SG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SG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70DBB2-AA8E-2348-8B11-633E6507F399}" type="slidenum">
              <a:rPr kumimoji="1" lang="zh-SG" altLang="en-US" smtClean="0"/>
              <a:t>‹#›</a:t>
            </a:fld>
            <a:endParaRPr kumimoji="1" lang="zh-SG" altLang="en-US"/>
          </a:p>
        </p:txBody>
      </p:sp>
    </p:spTree>
    <p:extLst>
      <p:ext uri="{BB962C8B-B14F-4D97-AF65-F5344CB8AC3E}">
        <p14:creationId xmlns:p14="http://schemas.microsoft.com/office/powerpoint/2010/main" val="15066217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1pPr>
    <a:lvl2pPr marL="3429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2pPr>
    <a:lvl3pPr marL="6858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3pPr>
    <a:lvl4pPr marL="10287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4pPr>
    <a:lvl5pPr marL="13716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5pPr>
    <a:lvl6pPr marL="17145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6pPr>
    <a:lvl7pPr marL="20574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7pPr>
    <a:lvl8pPr marL="24003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8pPr>
    <a:lvl9pPr marL="27432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SG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970DBB2-AA8E-2348-8B11-633E6507F399}" type="slidenum">
              <a:rPr kumimoji="1" lang="zh-SG" altLang="en-US" smtClean="0"/>
              <a:t>1</a:t>
            </a:fld>
            <a:endParaRPr kumimoji="1" lang="zh-SG" altLang="en-US"/>
          </a:p>
        </p:txBody>
      </p:sp>
    </p:spTree>
    <p:extLst>
      <p:ext uri="{BB962C8B-B14F-4D97-AF65-F5344CB8AC3E}">
        <p14:creationId xmlns:p14="http://schemas.microsoft.com/office/powerpoint/2010/main" val="10213808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85F3A-67D7-984C-976F-A73C5244D5E0}" type="datetimeFigureOut">
              <a:rPr kumimoji="1" lang="zh-SG" altLang="en-US" smtClean="0"/>
              <a:t>20/02/26</a:t>
            </a:fld>
            <a:endParaRPr kumimoji="1" lang="zh-SG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SG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1FFA5-AA07-CE49-BA15-ABFFE6736E63}" type="slidenum">
              <a:rPr kumimoji="1" lang="zh-SG" altLang="en-US" smtClean="0"/>
              <a:t>‹#›</a:t>
            </a:fld>
            <a:endParaRPr kumimoji="1" lang="zh-SG" altLang="en-US"/>
          </a:p>
        </p:txBody>
      </p:sp>
    </p:spTree>
    <p:extLst>
      <p:ext uri="{BB962C8B-B14F-4D97-AF65-F5344CB8AC3E}">
        <p14:creationId xmlns:p14="http://schemas.microsoft.com/office/powerpoint/2010/main" val="1801072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85F3A-67D7-984C-976F-A73C5244D5E0}" type="datetimeFigureOut">
              <a:rPr kumimoji="1" lang="zh-SG" altLang="en-US" smtClean="0"/>
              <a:t>20/02/26</a:t>
            </a:fld>
            <a:endParaRPr kumimoji="1" lang="zh-SG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SG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1FFA5-AA07-CE49-BA15-ABFFE6736E63}" type="slidenum">
              <a:rPr kumimoji="1" lang="zh-SG" altLang="en-US" smtClean="0"/>
              <a:t>‹#›</a:t>
            </a:fld>
            <a:endParaRPr kumimoji="1" lang="zh-SG" altLang="en-US"/>
          </a:p>
        </p:txBody>
      </p:sp>
    </p:spTree>
    <p:extLst>
      <p:ext uri="{BB962C8B-B14F-4D97-AF65-F5344CB8AC3E}">
        <p14:creationId xmlns:p14="http://schemas.microsoft.com/office/powerpoint/2010/main" val="5675515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85F3A-67D7-984C-976F-A73C5244D5E0}" type="datetimeFigureOut">
              <a:rPr kumimoji="1" lang="zh-SG" altLang="en-US" smtClean="0"/>
              <a:t>20/02/26</a:t>
            </a:fld>
            <a:endParaRPr kumimoji="1" lang="zh-SG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SG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1FFA5-AA07-CE49-BA15-ABFFE6736E63}" type="slidenum">
              <a:rPr kumimoji="1" lang="zh-SG" altLang="en-US" smtClean="0"/>
              <a:t>‹#›</a:t>
            </a:fld>
            <a:endParaRPr kumimoji="1" lang="zh-SG" altLang="en-US"/>
          </a:p>
        </p:txBody>
      </p:sp>
    </p:spTree>
    <p:extLst>
      <p:ext uri="{BB962C8B-B14F-4D97-AF65-F5344CB8AC3E}">
        <p14:creationId xmlns:p14="http://schemas.microsoft.com/office/powerpoint/2010/main" val="42807186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85F3A-67D7-984C-976F-A73C5244D5E0}" type="datetimeFigureOut">
              <a:rPr kumimoji="1" lang="zh-SG" altLang="en-US" smtClean="0"/>
              <a:t>20/02/26</a:t>
            </a:fld>
            <a:endParaRPr kumimoji="1" lang="zh-SG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SG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1FFA5-AA07-CE49-BA15-ABFFE6736E63}" type="slidenum">
              <a:rPr kumimoji="1" lang="zh-SG" altLang="en-US" smtClean="0"/>
              <a:t>‹#›</a:t>
            </a:fld>
            <a:endParaRPr kumimoji="1" lang="zh-SG" altLang="en-US"/>
          </a:p>
        </p:txBody>
      </p:sp>
    </p:spTree>
    <p:extLst>
      <p:ext uri="{BB962C8B-B14F-4D97-AF65-F5344CB8AC3E}">
        <p14:creationId xmlns:p14="http://schemas.microsoft.com/office/powerpoint/2010/main" val="34124117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85F3A-67D7-984C-976F-A73C5244D5E0}" type="datetimeFigureOut">
              <a:rPr kumimoji="1" lang="zh-SG" altLang="en-US" smtClean="0"/>
              <a:t>20/02/26</a:t>
            </a:fld>
            <a:endParaRPr kumimoji="1" lang="zh-SG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SG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1FFA5-AA07-CE49-BA15-ABFFE6736E63}" type="slidenum">
              <a:rPr kumimoji="1" lang="zh-SG" altLang="en-US" smtClean="0"/>
              <a:t>‹#›</a:t>
            </a:fld>
            <a:endParaRPr kumimoji="1" lang="zh-SG" altLang="en-US"/>
          </a:p>
        </p:txBody>
      </p:sp>
    </p:spTree>
    <p:extLst>
      <p:ext uri="{BB962C8B-B14F-4D97-AF65-F5344CB8AC3E}">
        <p14:creationId xmlns:p14="http://schemas.microsoft.com/office/powerpoint/2010/main" val="42094924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85F3A-67D7-984C-976F-A73C5244D5E0}" type="datetimeFigureOut">
              <a:rPr kumimoji="1" lang="zh-SG" altLang="en-US" smtClean="0"/>
              <a:t>20/02/26</a:t>
            </a:fld>
            <a:endParaRPr kumimoji="1" lang="zh-SG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SG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1FFA5-AA07-CE49-BA15-ABFFE6736E63}" type="slidenum">
              <a:rPr kumimoji="1" lang="zh-SG" altLang="en-US" smtClean="0"/>
              <a:t>‹#›</a:t>
            </a:fld>
            <a:endParaRPr kumimoji="1" lang="zh-SG" altLang="en-US"/>
          </a:p>
        </p:txBody>
      </p:sp>
    </p:spTree>
    <p:extLst>
      <p:ext uri="{BB962C8B-B14F-4D97-AF65-F5344CB8AC3E}">
        <p14:creationId xmlns:p14="http://schemas.microsoft.com/office/powerpoint/2010/main" val="38432847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85F3A-67D7-984C-976F-A73C5244D5E0}" type="datetimeFigureOut">
              <a:rPr kumimoji="1" lang="zh-SG" altLang="en-US" smtClean="0"/>
              <a:t>20/02/26</a:t>
            </a:fld>
            <a:endParaRPr kumimoji="1" lang="zh-SG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SG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1FFA5-AA07-CE49-BA15-ABFFE6736E63}" type="slidenum">
              <a:rPr kumimoji="1" lang="zh-SG" altLang="en-US" smtClean="0"/>
              <a:t>‹#›</a:t>
            </a:fld>
            <a:endParaRPr kumimoji="1" lang="zh-SG" altLang="en-US"/>
          </a:p>
        </p:txBody>
      </p:sp>
    </p:spTree>
    <p:extLst>
      <p:ext uri="{BB962C8B-B14F-4D97-AF65-F5344CB8AC3E}">
        <p14:creationId xmlns:p14="http://schemas.microsoft.com/office/powerpoint/2010/main" val="42031841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85F3A-67D7-984C-976F-A73C5244D5E0}" type="datetimeFigureOut">
              <a:rPr kumimoji="1" lang="zh-SG" altLang="en-US" smtClean="0"/>
              <a:t>20/02/26</a:t>
            </a:fld>
            <a:endParaRPr kumimoji="1" lang="zh-SG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SG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1FFA5-AA07-CE49-BA15-ABFFE6736E63}" type="slidenum">
              <a:rPr kumimoji="1" lang="zh-SG" altLang="en-US" smtClean="0"/>
              <a:t>‹#›</a:t>
            </a:fld>
            <a:endParaRPr kumimoji="1" lang="zh-SG" altLang="en-US"/>
          </a:p>
        </p:txBody>
      </p:sp>
    </p:spTree>
    <p:extLst>
      <p:ext uri="{BB962C8B-B14F-4D97-AF65-F5344CB8AC3E}">
        <p14:creationId xmlns:p14="http://schemas.microsoft.com/office/powerpoint/2010/main" val="40342130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85F3A-67D7-984C-976F-A73C5244D5E0}" type="datetimeFigureOut">
              <a:rPr kumimoji="1" lang="zh-SG" altLang="en-US" smtClean="0"/>
              <a:t>20/02/26</a:t>
            </a:fld>
            <a:endParaRPr kumimoji="1" lang="zh-SG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SG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1FFA5-AA07-CE49-BA15-ABFFE6736E63}" type="slidenum">
              <a:rPr kumimoji="1" lang="zh-SG" altLang="en-US" smtClean="0"/>
              <a:t>‹#›</a:t>
            </a:fld>
            <a:endParaRPr kumimoji="1" lang="zh-SG" altLang="en-US"/>
          </a:p>
        </p:txBody>
      </p:sp>
    </p:spTree>
    <p:extLst>
      <p:ext uri="{BB962C8B-B14F-4D97-AF65-F5344CB8AC3E}">
        <p14:creationId xmlns:p14="http://schemas.microsoft.com/office/powerpoint/2010/main" val="8795534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85F3A-67D7-984C-976F-A73C5244D5E0}" type="datetimeFigureOut">
              <a:rPr kumimoji="1" lang="zh-SG" altLang="en-US" smtClean="0"/>
              <a:t>20/02/26</a:t>
            </a:fld>
            <a:endParaRPr kumimoji="1" lang="zh-SG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SG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1FFA5-AA07-CE49-BA15-ABFFE6736E63}" type="slidenum">
              <a:rPr kumimoji="1" lang="zh-SG" altLang="en-US" smtClean="0"/>
              <a:t>‹#›</a:t>
            </a:fld>
            <a:endParaRPr kumimoji="1" lang="zh-SG" altLang="en-US"/>
          </a:p>
        </p:txBody>
      </p:sp>
    </p:spTree>
    <p:extLst>
      <p:ext uri="{BB962C8B-B14F-4D97-AF65-F5344CB8AC3E}">
        <p14:creationId xmlns:p14="http://schemas.microsoft.com/office/powerpoint/2010/main" val="13608642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85F3A-67D7-984C-976F-A73C5244D5E0}" type="datetimeFigureOut">
              <a:rPr kumimoji="1" lang="zh-SG" altLang="en-US" smtClean="0"/>
              <a:t>20/02/26</a:t>
            </a:fld>
            <a:endParaRPr kumimoji="1" lang="zh-SG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SG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1FFA5-AA07-CE49-BA15-ABFFE6736E63}" type="slidenum">
              <a:rPr kumimoji="1" lang="zh-SG" altLang="en-US" smtClean="0"/>
              <a:t>‹#›</a:t>
            </a:fld>
            <a:endParaRPr kumimoji="1" lang="zh-SG" altLang="en-US"/>
          </a:p>
        </p:txBody>
      </p:sp>
    </p:spTree>
    <p:extLst>
      <p:ext uri="{BB962C8B-B14F-4D97-AF65-F5344CB8AC3E}">
        <p14:creationId xmlns:p14="http://schemas.microsoft.com/office/powerpoint/2010/main" val="29278907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6B85F3A-67D7-984C-976F-A73C5244D5E0}" type="datetimeFigureOut">
              <a:rPr kumimoji="1" lang="zh-SG" altLang="en-US" smtClean="0"/>
              <a:t>20/02/26</a:t>
            </a:fld>
            <a:endParaRPr kumimoji="1" lang="zh-SG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zh-SG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531FFA5-AA07-CE49-BA15-ABFFE6736E63}" type="slidenum">
              <a:rPr kumimoji="1" lang="zh-SG" altLang="en-US" smtClean="0"/>
              <a:t>‹#›</a:t>
            </a:fld>
            <a:endParaRPr kumimoji="1" lang="zh-SG" altLang="en-US"/>
          </a:p>
        </p:txBody>
      </p:sp>
    </p:spTree>
    <p:extLst>
      <p:ext uri="{BB962C8B-B14F-4D97-AF65-F5344CB8AC3E}">
        <p14:creationId xmlns:p14="http://schemas.microsoft.com/office/powerpoint/2010/main" val="22917259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tif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0" Type="http://schemas.openxmlformats.org/officeDocument/2006/relationships/image" Target="../media/image8.png"/><Relationship Id="rId4" Type="http://schemas.openxmlformats.org/officeDocument/2006/relationships/image" Target="../media/image2.emf"/><Relationship Id="rId9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90BEF1E-71EA-8942-A006-6639C646852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文本框 20">
            <a:extLst>
              <a:ext uri="{FF2B5EF4-FFF2-40B4-BE49-F238E27FC236}">
                <a16:creationId xmlns:a16="http://schemas.microsoft.com/office/drawing/2014/main" id="{956C3354-DEB9-0046-C759-C5AB6062635F}"/>
              </a:ext>
            </a:extLst>
          </p:cNvPr>
          <p:cNvSpPr txBox="1"/>
          <p:nvPr/>
        </p:nvSpPr>
        <p:spPr>
          <a:xfrm>
            <a:off x="3428904" y="274449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SG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zh-SG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19249262-3233-68C1-DE3C-22E2CB03489A}"/>
              </a:ext>
            </a:extLst>
          </p:cNvPr>
          <p:cNvSpPr txBox="1"/>
          <p:nvPr/>
        </p:nvSpPr>
        <p:spPr>
          <a:xfrm>
            <a:off x="-8909" y="5113034"/>
            <a:ext cx="304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SG" sz="14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zh-SG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DA175DE4-B009-BE79-4E78-7D1A2D3F2190}"/>
              </a:ext>
            </a:extLst>
          </p:cNvPr>
          <p:cNvSpPr txBox="1"/>
          <p:nvPr/>
        </p:nvSpPr>
        <p:spPr>
          <a:xfrm>
            <a:off x="69827" y="148087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SG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zh-SG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70AF753C-37CD-BD88-F46A-825337D1565A}"/>
              </a:ext>
            </a:extLst>
          </p:cNvPr>
          <p:cNvSpPr txBox="1"/>
          <p:nvPr/>
        </p:nvSpPr>
        <p:spPr>
          <a:xfrm>
            <a:off x="88906" y="6865082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SG" sz="14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kumimoji="1" lang="zh-SG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81233349-6873-1EC7-CCE1-0CE020128782}"/>
              </a:ext>
            </a:extLst>
          </p:cNvPr>
          <p:cNvSpPr txBox="1"/>
          <p:nvPr/>
        </p:nvSpPr>
        <p:spPr>
          <a:xfrm>
            <a:off x="2770095" y="5108056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SG" sz="14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kumimoji="1" lang="zh-SG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204138D4-4A1A-40F7-786B-66997AED73B1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/>
          <a:stretch/>
        </p:blipFill>
        <p:spPr>
          <a:xfrm>
            <a:off x="-8909" y="1739828"/>
            <a:ext cx="1419191" cy="1272378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F16DB1D8-665B-A93D-B93B-B193D5E4C40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87551" y="1739828"/>
            <a:ext cx="1382544" cy="1279459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A64AF4B5-B3C3-F834-AEF7-394E52A9E97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70902" y="1731907"/>
            <a:ext cx="1380038" cy="1266035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5D183CB9-826A-5F62-B9CB-BE94C70348B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10447" y="1742579"/>
            <a:ext cx="1350038" cy="1266035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21D309DA-08A8-9038-B3E0-78499998BF7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419991" y="1746222"/>
            <a:ext cx="1436645" cy="1273664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21D1803F-8DE6-359E-5C16-10F7812E3093}"/>
              </a:ext>
            </a:extLst>
          </p:cNvPr>
          <p:cNvSpPr txBox="1"/>
          <p:nvPr/>
        </p:nvSpPr>
        <p:spPr>
          <a:xfrm>
            <a:off x="80190" y="274450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SG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zh-SG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4E5F6146-88C4-0FF8-3E12-F87D06B77AC9}"/>
              </a:ext>
            </a:extLst>
          </p:cNvPr>
          <p:cNvSpPr txBox="1"/>
          <p:nvPr/>
        </p:nvSpPr>
        <p:spPr>
          <a:xfrm>
            <a:off x="69827" y="293836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SG" sz="1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zh-SG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EC9C286F-B146-F9E6-7FBB-31116AD0D896}"/>
              </a:ext>
            </a:extLst>
          </p:cNvPr>
          <p:cNvSpPr txBox="1"/>
          <p:nvPr/>
        </p:nvSpPr>
        <p:spPr>
          <a:xfrm>
            <a:off x="2055242" y="7211598"/>
            <a:ext cx="221887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SG" sz="800" b="1" dirty="0"/>
              <a:t>Validation cohort 1 – Queensland University</a:t>
            </a:r>
            <a:endParaRPr kumimoji="1" lang="zh-SG" altLang="en-US" sz="800" b="1" dirty="0"/>
          </a:p>
        </p:txBody>
      </p:sp>
      <p:pic>
        <p:nvPicPr>
          <p:cNvPr id="19" name="图片 18" descr="图形用户界面&#10;&#10;AI 生成的内容可能不正确。">
            <a:extLst>
              <a:ext uri="{FF2B5EF4-FFF2-40B4-BE49-F238E27FC236}">
                <a16:creationId xmlns:a16="http://schemas.microsoft.com/office/drawing/2014/main" id="{58C75881-3FEA-62F2-3419-48A8C49C6EBD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b="1863"/>
          <a:stretch>
            <a:fillRect/>
          </a:stretch>
        </p:blipFill>
        <p:spPr>
          <a:xfrm>
            <a:off x="413034" y="6664310"/>
            <a:ext cx="5872416" cy="3241690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CE3D205A-1576-1A5C-6B22-A454D3A350C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9827" y="5420811"/>
            <a:ext cx="2775027" cy="1401529"/>
          </a:xfrm>
          <a:prstGeom prst="rect">
            <a:avLst/>
          </a:prstGeom>
        </p:spPr>
      </p:pic>
      <p:graphicFrame>
        <p:nvGraphicFramePr>
          <p:cNvPr id="18" name="表格 17">
            <a:extLst>
              <a:ext uri="{FF2B5EF4-FFF2-40B4-BE49-F238E27FC236}">
                <a16:creationId xmlns:a16="http://schemas.microsoft.com/office/drawing/2014/main" id="{A21309CD-7353-C05A-F52B-6EB36F1C6BE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89889556"/>
              </p:ext>
            </p:extLst>
          </p:nvPr>
        </p:nvGraphicFramePr>
        <p:xfrm>
          <a:off x="95583" y="3202770"/>
          <a:ext cx="3179193" cy="1945320"/>
        </p:xfrm>
        <a:graphic>
          <a:graphicData uri="http://schemas.openxmlformats.org/drawingml/2006/table">
            <a:tbl>
              <a:tblPr firstRow="1" bandRow="1"/>
              <a:tblGrid>
                <a:gridCol w="732594">
                  <a:extLst>
                    <a:ext uri="{9D8B030D-6E8A-4147-A177-3AD203B41FA5}">
                      <a16:colId xmlns:a16="http://schemas.microsoft.com/office/drawing/2014/main" val="3221347229"/>
                    </a:ext>
                  </a:extLst>
                </a:gridCol>
                <a:gridCol w="1145627">
                  <a:extLst>
                    <a:ext uri="{9D8B030D-6E8A-4147-A177-3AD203B41FA5}">
                      <a16:colId xmlns:a16="http://schemas.microsoft.com/office/drawing/2014/main" val="1488447898"/>
                    </a:ext>
                  </a:extLst>
                </a:gridCol>
                <a:gridCol w="1300972">
                  <a:extLst>
                    <a:ext uri="{9D8B030D-6E8A-4147-A177-3AD203B41FA5}">
                      <a16:colId xmlns:a16="http://schemas.microsoft.com/office/drawing/2014/main" val="443295225"/>
                    </a:ext>
                  </a:extLst>
                </a:gridCol>
              </a:tblGrid>
              <a:tr h="274715">
                <a:tc>
                  <a:txBody>
                    <a:bodyPr/>
                    <a:lstStyle/>
                    <a:p>
                      <a:pPr algn="ctr"/>
                      <a:r>
                        <a:rPr lang="en-US" altLang="zh-SG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ature Gene</a:t>
                      </a:r>
                      <a:endParaRPr lang="zh-SG" altLang="en-US"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SG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ll Name</a:t>
                      </a:r>
                      <a:endParaRPr lang="zh-SG" altLang="en-US"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SG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Function</a:t>
                      </a:r>
                      <a:endParaRPr lang="zh-SG" altLang="en-US"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04770754"/>
                  </a:ext>
                </a:extLst>
              </a:tr>
              <a:tr h="40608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zh-SG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BP5</a:t>
                      </a:r>
                      <a:endParaRPr lang="zh-SG" altLang="en-US"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SG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tty Acid Binding Protein 5</a:t>
                      </a:r>
                      <a:endParaRPr lang="zh-SG" altLang="en-US"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SG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atty acid uptake, transport, and metabolism.</a:t>
                      </a:r>
                      <a:endParaRPr lang="zh-SG" altLang="en-US"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957076017"/>
                  </a:ext>
                </a:extLst>
              </a:tr>
              <a:tr h="40608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zh-SG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6</a:t>
                      </a:r>
                      <a:endParaRPr lang="zh-SG" altLang="en-US"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SG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6 Molecule</a:t>
                      </a:r>
                      <a:endParaRPr lang="zh-SG" altLang="en-US"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SG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nds long chain fatty acids and function in fatty acid transport.</a:t>
                      </a:r>
                      <a:endParaRPr lang="zh-SG" altLang="en-US"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78412684"/>
                  </a:ext>
                </a:extLst>
              </a:tr>
              <a:tr h="40608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zh-SG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NMB</a:t>
                      </a:r>
                      <a:endParaRPr lang="zh-SG" altLang="en-US"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SG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nsmembrane Glycoprotein NMB</a:t>
                      </a:r>
                      <a:endParaRPr lang="zh-SG" altLang="en-US"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SG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volved in growth delay and reduction of metastatic potential.</a:t>
                      </a:r>
                      <a:endParaRPr lang="zh-SG" altLang="en-US"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07428059"/>
                  </a:ext>
                </a:extLst>
              </a:tr>
              <a:tr h="40608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zh-SG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CRO</a:t>
                      </a:r>
                      <a:endParaRPr lang="zh-SG" altLang="en-US"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SG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crophage Receptor With Collagenous Structure</a:t>
                      </a:r>
                      <a:endParaRPr lang="zh-SG" altLang="en-US"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SG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stitutively expressed in lymph-node macrophages.</a:t>
                      </a:r>
                      <a:endParaRPr lang="zh-SG" altLang="en-US"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749178734"/>
                  </a:ext>
                </a:extLst>
              </a:tr>
            </a:tbl>
          </a:graphicData>
        </a:graphic>
      </p:graphicFrame>
      <p:pic>
        <p:nvPicPr>
          <p:cNvPr id="4" name="图片 3">
            <a:extLst>
              <a:ext uri="{FF2B5EF4-FFF2-40B4-BE49-F238E27FC236}">
                <a16:creationId xmlns:a16="http://schemas.microsoft.com/office/drawing/2014/main" id="{E566097A-BC7C-0688-5945-018151B4BCE0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 r="18525"/>
          <a:stretch>
            <a:fillRect/>
          </a:stretch>
        </p:blipFill>
        <p:spPr>
          <a:xfrm>
            <a:off x="2996251" y="5331836"/>
            <a:ext cx="3772926" cy="1572096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AD79F248-C5A9-FE53-2A22-5D82C7446F59}"/>
              </a:ext>
            </a:extLst>
          </p:cNvPr>
          <p:cNvSpPr txBox="1"/>
          <p:nvPr/>
        </p:nvSpPr>
        <p:spPr>
          <a:xfrm>
            <a:off x="3142963" y="5169014"/>
            <a:ext cx="25891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SG" sz="900" b="1" dirty="0"/>
              <a:t>Validation cohort 1 - University </a:t>
            </a:r>
            <a:r>
              <a:rPr kumimoji="1" lang="en-US" altLang="zh-SG" sz="900" b="1"/>
              <a:t>of Queensland</a:t>
            </a:r>
            <a:endParaRPr kumimoji="1" lang="zh-SG" altLang="en-US" sz="900" b="1" dirty="0"/>
          </a:p>
        </p:txBody>
      </p:sp>
      <p:pic>
        <p:nvPicPr>
          <p:cNvPr id="23" name="图片 22">
            <a:extLst>
              <a:ext uri="{FF2B5EF4-FFF2-40B4-BE49-F238E27FC236}">
                <a16:creationId xmlns:a16="http://schemas.microsoft.com/office/drawing/2014/main" id="{4C0FE006-73F2-41FF-F140-F2B58A74E6EE}"/>
              </a:ext>
            </a:extLst>
          </p:cNvPr>
          <p:cNvPicPr>
            <a:picLocks noChangeAspect="1"/>
          </p:cNvPicPr>
          <p:nvPr/>
        </p:nvPicPr>
        <p:blipFill>
          <a:blip r:embed="rId11"/>
          <a:srcRect/>
          <a:stretch/>
        </p:blipFill>
        <p:spPr>
          <a:xfrm>
            <a:off x="3733796" y="274064"/>
            <a:ext cx="2727705" cy="1391404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E02DE215-C220-255F-DBFB-5F3701A716A4}"/>
              </a:ext>
            </a:extLst>
          </p:cNvPr>
          <p:cNvPicPr>
            <a:picLocks noChangeAspect="1"/>
          </p:cNvPicPr>
          <p:nvPr/>
        </p:nvPicPr>
        <p:blipFill>
          <a:blip r:embed="rId12"/>
          <a:srcRect/>
          <a:stretch/>
        </p:blipFill>
        <p:spPr>
          <a:xfrm>
            <a:off x="404705" y="274064"/>
            <a:ext cx="2921258" cy="1391404"/>
          </a:xfrm>
          <a:prstGeom prst="rect">
            <a:avLst/>
          </a:prstGeom>
        </p:spPr>
      </p:pic>
      <p:pic>
        <p:nvPicPr>
          <p:cNvPr id="30" name="图片 29" descr="图表&#10;&#10;AI 生成的内容可能不正确。">
            <a:extLst>
              <a:ext uri="{FF2B5EF4-FFF2-40B4-BE49-F238E27FC236}">
                <a16:creationId xmlns:a16="http://schemas.microsoft.com/office/drawing/2014/main" id="{7B3BBF09-1C6A-033A-5411-E962B67A6ADD}"/>
              </a:ext>
            </a:extLst>
          </p:cNvPr>
          <p:cNvPicPr>
            <a:picLocks noChangeAspect="1"/>
          </p:cNvPicPr>
          <p:nvPr/>
        </p:nvPicPr>
        <p:blipFill>
          <a:blip r:embed="rId13"/>
          <a:srcRect l="971" t="33913" r="11747" b="34921"/>
          <a:stretch>
            <a:fillRect/>
          </a:stretch>
        </p:blipFill>
        <p:spPr>
          <a:xfrm>
            <a:off x="3325963" y="3276587"/>
            <a:ext cx="3530156" cy="1031332"/>
          </a:xfrm>
          <a:prstGeom prst="rect">
            <a:avLst/>
          </a:prstGeom>
        </p:spPr>
      </p:pic>
      <p:sp>
        <p:nvSpPr>
          <p:cNvPr id="31" name="文本框 30">
            <a:extLst>
              <a:ext uri="{FF2B5EF4-FFF2-40B4-BE49-F238E27FC236}">
                <a16:creationId xmlns:a16="http://schemas.microsoft.com/office/drawing/2014/main" id="{2E41E8A5-925B-7B1B-915A-FC6966115EE5}"/>
              </a:ext>
            </a:extLst>
          </p:cNvPr>
          <p:cNvSpPr txBox="1"/>
          <p:nvPr/>
        </p:nvSpPr>
        <p:spPr>
          <a:xfrm>
            <a:off x="3472141" y="2938361"/>
            <a:ext cx="304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SG" sz="14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zh-SG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图片 31">
            <a:extLst>
              <a:ext uri="{FF2B5EF4-FFF2-40B4-BE49-F238E27FC236}">
                <a16:creationId xmlns:a16="http://schemas.microsoft.com/office/drawing/2014/main" id="{38430E56-713B-3B03-4CE2-CF8ECFD009CB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 l="83416" t="39266" b="45125"/>
          <a:stretch>
            <a:fillRect/>
          </a:stretch>
        </p:blipFill>
        <p:spPr>
          <a:xfrm>
            <a:off x="6096000" y="5106490"/>
            <a:ext cx="737659" cy="235705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84AAB71C-9E1D-7178-BB50-507B06F53DFA}"/>
              </a:ext>
            </a:extLst>
          </p:cNvPr>
          <p:cNvSpPr txBox="1"/>
          <p:nvPr/>
        </p:nvSpPr>
        <p:spPr>
          <a:xfrm>
            <a:off x="0" y="-74891"/>
            <a:ext cx="2967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SG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</a:t>
            </a:r>
          </a:p>
        </p:txBody>
      </p:sp>
    </p:spTree>
    <p:extLst>
      <p:ext uri="{BB962C8B-B14F-4D97-AF65-F5344CB8AC3E}">
        <p14:creationId xmlns:p14="http://schemas.microsoft.com/office/powerpoint/2010/main" val="6130487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主题​​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074</TotalTime>
  <Words>88</Words>
  <Application>Microsoft Macintosh PowerPoint</Application>
  <PresentationFormat>A4 纸张(210x297 毫米)</PresentationFormat>
  <Paragraphs>27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洪 亮</dc:creator>
  <cp:lastModifiedBy>洪 亮</cp:lastModifiedBy>
  <cp:revision>289</cp:revision>
  <dcterms:created xsi:type="dcterms:W3CDTF">2025-07-03T05:41:50Z</dcterms:created>
  <dcterms:modified xsi:type="dcterms:W3CDTF">2026-02-20T03:26:32Z</dcterms:modified>
</cp:coreProperties>
</file>